
<file path=[Content_Types].xml><?xml version="1.0" encoding="utf-8"?>
<Types xmlns="http://schemas.openxmlformats.org/package/2006/content-types">
  <Default Extension="xml" ContentType="application/xml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84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garita Trobos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Inget format, tabellrutnät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50"/>
    <p:restoredTop sz="72267"/>
  </p:normalViewPr>
  <p:slideViewPr>
    <p:cSldViewPr snapToGrid="0" snapToObjects="1">
      <p:cViewPr>
        <p:scale>
          <a:sx n="209" d="100"/>
          <a:sy n="209" d="100"/>
        </p:scale>
        <p:origin x="1792" y="6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commentAuthors" Target="commentAuthors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>
            <a:extLst>
              <a:ext uri="{FF2B5EF4-FFF2-40B4-BE49-F238E27FC236}">
                <a16:creationId xmlns:a16="http://schemas.microsoft.com/office/drawing/2014/main" xmlns="" id="{198921C1-C7CE-0945-B08F-D33E1D2227F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xmlns="" id="{7455C5F2-AD4B-6D4A-92F1-556994B9A8E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F0ADD4-4C1D-684B-966C-620AB3A1911B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xmlns="" id="{3C83FB38-2692-1D41-B407-7C36B1049A03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xmlns="" id="{C3FB064C-37CA-9A43-8FCC-9BF8FECEC84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113AE8-E413-0746-91D1-7D0EC98F19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82723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E35772-2B33-6146-AA35-EE21E47F43B4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70E62A-59F8-5F4B-BFD4-220F0E5C530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571765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25D9A421-B78A-1142-8488-E02EEC66F3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xmlns="" id="{562E014F-3575-BE4A-88DE-5E35250F79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om du vill redige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FAB44CCC-AE65-F24C-915A-22A970E9F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2FB237B5-D81D-7A4E-B15D-276337047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CAC2EB30-7BDA-0041-AF96-37A0A2D16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14217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9F76A124-D634-364D-B74A-00BF724655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xmlns="" id="{194535BE-3772-434A-A211-624B129F9B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D55AF121-D4FA-764B-92F5-2ABC646CE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65AD5065-A3CA-194B-A254-2F16402B2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D7279F7C-7163-044C-9744-9E63275C4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16111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xmlns="" id="{A9200916-B169-DB4C-A431-60F4A2B0CA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xmlns="" id="{5C92342D-ED08-F049-A5C3-1CDD10CB5E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BA0D0F60-F73A-494B-ACBD-5556C88E3D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93D32A5-263C-FB4D-80D9-F3BDC6E1B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631C0574-6EA3-4A47-AAB5-6BB17FE04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32634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194A6F5F-858C-B74A-92DB-D19A25700D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3885C046-C992-BA48-97A2-A9972F4138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48F84843-7A76-934A-81E9-0AC4432D2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6D6B7F9-67FC-184B-98B1-1EE65D360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03BE9548-BD81-8147-AF68-6B51F746A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61969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731FC51B-9208-4D4C-929D-94307B0B2C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877C8978-D4F4-CB4B-A975-57EAE62C8E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5293699C-23E4-A847-8494-A3DAF59D8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BE3D17C-8164-3B41-B452-298F9D95A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30A887D2-CED1-374D-8FA7-24462A023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20992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FEA21CCA-802A-4D43-9A14-5A8281AA60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D95785CF-4A64-594B-AA5C-7388DB59B5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xmlns="" id="{5FF9924C-EA31-C04E-838F-1F1C79DCE4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6729B584-14AF-3845-8475-76B465429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BC5CCAB2-9C29-F94A-8F20-1B4E82740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1D06323A-537B-B147-A529-C42E646AB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71349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EC593B24-B690-D440-B5D3-5F475B3FFC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A23B8E26-BA0D-3646-A21A-9149D3383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xmlns="" id="{AD464A3F-2EAC-394B-9710-5E9C52772E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xmlns="" id="{875FF106-5B78-E949-84B3-46D2017212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xmlns="" id="{7374BB03-0242-044B-B9CC-1C329E6AE9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xmlns="" id="{B5AF69DF-E420-CF4A-8AB5-AFABD54F0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xmlns="" id="{A63AC4C3-3684-2A43-8C2E-8652C4553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xmlns="" id="{56CCDD41-398F-AE42-882E-C7848A2DC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53684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741106EC-0875-924F-B906-E921245277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xmlns="" id="{A4CB0133-5180-3341-953E-1C730F27A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xmlns="" id="{D5B7FBE3-65B8-7A48-89A8-77F08256B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xmlns="" id="{202A3E99-E587-7D4E-911E-1EE2719B2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02934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xmlns="" id="{59D41A88-7EAF-834E-A3B3-D41B2CD4C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xmlns="" id="{D592D6CB-FA2A-364E-BADF-DA5327BDF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xmlns="" id="{E0BDB220-FFB1-CF45-965D-81F332588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01015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3A4F5AC9-7BB2-F344-B533-8AD3DC268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DF096EFF-C49F-AE4F-8816-6999AF30F2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xmlns="" id="{37264A3A-789C-FB45-BF10-8F116C693D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F43DC1F7-4861-EA48-B2F5-444E5A2E4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58BBA83B-C5E9-EA4E-A89D-8DE0CABE4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4701A9B1-E942-6D44-BD2A-412946873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94712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1531F70A-4BAE-6C49-B277-B40327DB6E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xmlns="" id="{23EF0424-23A7-974A-B5E3-55110AF893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xmlns="" id="{B3DFC028-C4C2-DC42-9924-D5869440FD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82E77B12-D9A7-5047-94B5-DCEDCDEE2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4FE16373-E66F-0546-80BB-6420284D1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5143BC7B-E1E6-F844-94F5-BB2C3C840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77567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xmlns="" id="{CD7F0D77-2043-F641-A829-C836BA1D29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A6048C07-F533-3B44-9A5A-BEE2D02733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3638D838-DFBC-0246-A9C3-F18E481974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80B54D6-E4E3-8B4B-AE58-1FE7569462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030D401E-7AE5-6140-B6D6-121EC3B091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02768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614676" y="361696"/>
            <a:ext cx="6480048" cy="5217255"/>
            <a:chOff x="2614676" y="361696"/>
            <a:chExt cx="6480048" cy="5217255"/>
          </a:xfrm>
        </p:grpSpPr>
        <p:pic>
          <p:nvPicPr>
            <p:cNvPr id="4" name="Picture 3" descr="Image 1.TI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4676" y="361696"/>
              <a:ext cx="6480048" cy="3645408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871781" y="4040068"/>
              <a:ext cx="6096000" cy="153888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just">
                <a:lnSpc>
                  <a:spcPct val="200000"/>
                </a:lnSpc>
              </a:pPr>
              <a:r>
                <a:rPr lang="en-US" sz="1200" b="1" dirty="0">
                  <a:latin typeface="Times New Roman"/>
                  <a:cs typeface="Times New Roman"/>
                </a:rPr>
                <a:t>Supplementary material 1:</a:t>
              </a:r>
              <a:r>
                <a:rPr lang="en-US" sz="1200" dirty="0">
                  <a:latin typeface="Times New Roman"/>
                  <a:cs typeface="Times New Roman"/>
                </a:rPr>
                <a:t> Growth curves of </a:t>
              </a:r>
              <a:r>
                <a:rPr lang="en-US" sz="1200" i="1" dirty="0">
                  <a:latin typeface="Times New Roman"/>
                  <a:cs typeface="Times New Roman"/>
                </a:rPr>
                <a:t>Staphylococcus </a:t>
              </a:r>
              <a:r>
                <a:rPr lang="en-US" sz="1200" i="1" dirty="0" err="1">
                  <a:latin typeface="Times New Roman"/>
                  <a:cs typeface="Times New Roman"/>
                </a:rPr>
                <a:t>epidermidis</a:t>
              </a:r>
              <a:r>
                <a:rPr lang="en-US" sz="1200" i="1" dirty="0">
                  <a:latin typeface="Times New Roman"/>
                  <a:cs typeface="Times New Roman"/>
                </a:rPr>
                <a:t> </a:t>
              </a:r>
              <a:r>
                <a:rPr lang="en-US" sz="1200" dirty="0">
                  <a:latin typeface="Times New Roman"/>
                  <a:cs typeface="Times New Roman"/>
                </a:rPr>
                <a:t>CCUG 64523 stimulated with EVs (5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) under four different culture conditions: A) 0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 GEN, B) 0.03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 GEN, C) 0.06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 GEN and D) 0.12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 GEN. Each curve represents the mean (n=3) ± SEM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37277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701</TotalTime>
  <Words>81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ema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paper IV</dc:title>
  <dc:creator>Microsoft Office-användare</dc:creator>
  <cp:lastModifiedBy>Margarita Trobos</cp:lastModifiedBy>
  <cp:revision>821</cp:revision>
  <cp:lastPrinted>2018-11-05T16:43:54Z</cp:lastPrinted>
  <dcterms:created xsi:type="dcterms:W3CDTF">2018-04-10T08:43:01Z</dcterms:created>
  <dcterms:modified xsi:type="dcterms:W3CDTF">2019-11-05T10:00:32Z</dcterms:modified>
</cp:coreProperties>
</file>